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 showGuides="1">
      <p:cViewPr varScale="1">
        <p:scale>
          <a:sx n="72" d="100"/>
          <a:sy n="72" d="100"/>
        </p:scale>
        <p:origin x="2634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760953-69A8-DB56-F7A8-B423598540B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621191"/>
            <a:ext cx="5143500" cy="3448756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E031763-2F08-DC56-F6CC-1728DBB9D72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B0EB7C-9823-10A9-5CDA-023AC78227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B72990-534C-5F42-378E-85C3CF4A14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04F63E-06CE-ECA6-52CB-8BD02BA602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72371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5C321F-4186-1F57-9661-EFC9889A740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F0AA85A-A6FC-7E68-8AC5-54B2ECEB91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ECB009-CFEA-D8B4-647E-0BDFDA0A3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0AC1465-32E5-321D-4E17-1E7F646BC8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E086E05-2AF9-169A-A77A-761DA9F730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88355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D7016D5-B1D1-12B5-20D0-81B9B5E2D21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58AB8E-D7C2-D88C-927C-B65DFF38840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C82DE7-617A-C065-4312-5CAA3FFFA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2F0E8B1-D21D-A35F-FF8B-B6A9400E8B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570755F-5088-9B96-9FE1-104DDFB294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784813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ED2A004-9280-C73A-AB27-D25E2B5A4C6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6FE6614-1D35-2567-2C41-754785CD580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FDE202-771E-7AA4-DDE3-5D455422CB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C2FF5-D020-9CBF-FCDC-E75C9BFB74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C3228C-2EED-8962-0796-BCC03B8D4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579592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883A0D9-DFF8-D4BD-BD30-C51C8E7708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469622"/>
            <a:ext cx="5915025" cy="4120620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BDF684-C172-3F4C-EDA6-81D7FDF7C4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629225"/>
            <a:ext cx="5915025" cy="2166937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82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82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4BA3115-5D8D-ED94-D589-B535BA283F6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C40E5DE-1008-D8AD-D910-D5E5314A9A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E13E22-2734-84D4-CC48-0F90ED8B020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8441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CCAC99-019E-1B4A-B378-76CC817B3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D8B00C1-33C0-3930-4AFA-CDC7C4EE013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3F5A8AF-0C37-0D33-AC80-767FE28B35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7554D8-FCF6-1A49-929C-BD0A086116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EC37A6D-4973-7BEA-6FF0-482478973D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CE07B4-3106-DCB6-7D97-B87EBD6E61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00150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AE4A4FB-764C-23C8-7615-1D8CD84E69C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527404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EA102E-751D-CD4E-EBDB-0E10F0BC8CF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697FAD-233B-E0F2-70E4-F8ECA26C89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CB8068F-9F1F-DE13-81A7-4F046428B3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E4A74F3-0E68-F674-E797-C2D14ECCADE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207D3F8-7DC8-80FD-5A8D-DC617FDB2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B21D62D-F941-F588-8B8E-856681BDDCF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5D79076-3C50-F8E8-CD38-F7FA69E93F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2987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9D17E7-6308-EDB8-DDA3-730E233DBC2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A6C5DD9-0D0E-EF28-060F-30BC889B55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1B9B016-1B1E-69AC-E357-34C78BDAA2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61FC247-A700-D710-D2F8-EDF212C07A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32403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BB5462-5389-AEC2-8C02-049750D271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5FAB7F0-D513-C56B-C522-58BA4EDF7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78F3FE-A01D-9676-0193-DDCCF29DFA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84220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8D4A89-933A-CFDD-6B3A-9428D6176C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0E4454C-28FF-FA15-58E7-547FE8E7AD0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94B4E7-DDA5-2AC9-58E2-2F70E21D8F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45A203F-3664-352D-3848-13C9BC731EE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032D81D-98B4-C29B-A696-F267AAE783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C2F87E-37F6-BA43-46E2-DBEC878504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27379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79BF263-8641-7E97-AEBD-4DD9ABC81B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3" cy="23114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D2EF1E3-0653-DE38-2898-E45DAEFA151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426281"/>
            <a:ext cx="3471863" cy="7039681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EB6C35-BCC9-A705-7A61-8AA042B44F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3" cy="550562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402D00B-CA0B-F1FF-E36C-FC5E6FE50D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D56EBC3-0B90-C05B-C3E6-F4D808CD2D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4820478-12BD-A4F8-4C73-8D9A5199C3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22442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D947F13-8AAE-ACCC-4A97-321D6F32DA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527404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6A764C6-9368-4F54-3E46-C1C252C75F4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5A3BC36-E6B8-84E3-8A50-41414764041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9A4B8EA-D016-4A49-9F62-512E3F1E5EB1}" type="datetimeFigureOut">
              <a:rPr lang="en-US" smtClean="0"/>
              <a:t>10/9/20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75DAA-C2A5-7B52-3A5D-B9EF149CC2A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9181395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3527DF-D9D9-E8A4-BBCF-374B9B32B9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9181395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7199FDB-7E0F-5940-8911-A1D765D20975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654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43006D5A-2273-889F-8D2C-6638626C2AB0}"/>
              </a:ext>
            </a:extLst>
          </p:cNvPr>
          <p:cNvSpPr txBox="1"/>
          <p:nvPr/>
        </p:nvSpPr>
        <p:spPr>
          <a:xfrm>
            <a:off x="258418" y="8738153"/>
            <a:ext cx="6341163" cy="10464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S1: MAGE and CONGA measurements </a:t>
            </a:r>
            <a:endParaRPr lang="fr-FR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A – Typical fluctuations in CGM readings translated into peaks and nadirs according to mean amplitude of glycemic excursion (MAGE) definition.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B - Raw CGM data were manually spliced according to the diet (HS: high starch diet; HF: high fat diet) the animals received. They were analyzed according to MAGE and to CONGA (continuous overall net glycemic action: 1 h, 2 h and 6 h)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4">
            <a:extLst>
              <a:ext uri="{FF2B5EF4-FFF2-40B4-BE49-F238E27FC236}">
                <a16:creationId xmlns:a16="http://schemas.microsoft.com/office/drawing/2014/main" id="{BAB2CEF9-0AB2-4AF6-BEF9-1FBC9335BFE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21355" y="4996072"/>
            <a:ext cx="5440218" cy="3644345"/>
          </a:xfrm>
          <a:prstGeom prst="rect">
            <a:avLst/>
          </a:prstGeom>
        </p:spPr>
      </p:pic>
      <p:pic>
        <p:nvPicPr>
          <p:cNvPr id="3" name="Image 2">
            <a:extLst>
              <a:ext uri="{FF2B5EF4-FFF2-40B4-BE49-F238E27FC236}">
                <a16:creationId xmlns:a16="http://schemas.microsoft.com/office/drawing/2014/main" id="{30B658AE-68CF-4DAE-AF68-20520211E6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98914" y="812104"/>
            <a:ext cx="6466928" cy="4183968"/>
          </a:xfrm>
          <a:prstGeom prst="rect">
            <a:avLst/>
          </a:prstGeom>
        </p:spPr>
      </p:pic>
      <p:sp>
        <p:nvSpPr>
          <p:cNvPr id="2" name="ZoneTexte 1">
            <a:extLst>
              <a:ext uri="{FF2B5EF4-FFF2-40B4-BE49-F238E27FC236}">
                <a16:creationId xmlns:a16="http://schemas.microsoft.com/office/drawing/2014/main" id="{71BAC97F-84EE-410C-B178-343DD65248B7}"/>
              </a:ext>
            </a:extLst>
          </p:cNvPr>
          <p:cNvSpPr txBox="1"/>
          <p:nvPr/>
        </p:nvSpPr>
        <p:spPr>
          <a:xfrm>
            <a:off x="437453" y="179334"/>
            <a:ext cx="622838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 pilot study documenting nocturnal and diurnal glycemic excursions and their relationships in lean growing pigs fed contrasted diets 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ZoneTexte 4">
            <a:extLst>
              <a:ext uri="{FF2B5EF4-FFF2-40B4-BE49-F238E27FC236}">
                <a16:creationId xmlns:a16="http://schemas.microsoft.com/office/drawing/2014/main" id="{268551BF-327B-45B1-98A3-7121BD591ACA}"/>
              </a:ext>
            </a:extLst>
          </p:cNvPr>
          <p:cNvSpPr txBox="1"/>
          <p:nvPr/>
        </p:nvSpPr>
        <p:spPr>
          <a:xfrm>
            <a:off x="477159" y="642588"/>
            <a:ext cx="463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A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5D63561C-0AE4-4BF0-BEDC-ED2FE589A953}"/>
              </a:ext>
            </a:extLst>
          </p:cNvPr>
          <p:cNvSpPr txBox="1"/>
          <p:nvPr/>
        </p:nvSpPr>
        <p:spPr>
          <a:xfrm>
            <a:off x="477159" y="4996072"/>
            <a:ext cx="4634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42616759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94</TotalTime>
  <Words>107</Words>
  <Application>Microsoft Office PowerPoint</Application>
  <PresentationFormat>Format A4 (210 x 297 mm)</PresentationFormat>
  <Paragraphs>6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harles-Henri Malbert</dc:creator>
  <cp:lastModifiedBy>PHASE</cp:lastModifiedBy>
  <cp:revision>30</cp:revision>
  <dcterms:created xsi:type="dcterms:W3CDTF">2025-09-10T09:12:49Z</dcterms:created>
  <dcterms:modified xsi:type="dcterms:W3CDTF">2025-10-09T09:02:54Z</dcterms:modified>
</cp:coreProperties>
</file>